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0" r:id="rId3"/>
    <p:sldId id="271" r:id="rId4"/>
    <p:sldId id="272" r:id="rId5"/>
    <p:sldId id="273" r:id="rId6"/>
    <p:sldId id="268" r:id="rId7"/>
    <p:sldId id="274" r:id="rId8"/>
    <p:sldId id="275" r:id="rId9"/>
    <p:sldId id="276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38" y="2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562EABF-9A6E-46A7-8582-C925EB87C4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948C2178-D790-45F4-ADD2-5989F93934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23C3C47-BE5B-4D4F-93B7-031C6A35E2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0A-ECB5-4241-8711-E93198E77A6A}" type="datetimeFigureOut">
              <a:rPr lang="en-US" smtClean="0"/>
              <a:t>1/1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40DD746-BBE7-412A-9764-8FD2EBFFEA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65CDED9-8E1D-4B23-9090-9CBBF1CB0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D656-1A1A-484E-AAEF-12871F2463F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751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827616-1FFD-4AA5-9A30-2D00CA0AF6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B53A7A3-E7EE-4376-BEF6-01CDBFF38C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21C3FB4-9676-4B9F-A187-E943E4C07B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0A-ECB5-4241-8711-E93198E77A6A}" type="datetimeFigureOut">
              <a:rPr lang="en-US" smtClean="0"/>
              <a:t>1/1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E0C61F9-B8E3-475E-A163-88E7177BF5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176D1D3-8D11-4AA8-AB98-F9651DA297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D656-1A1A-484E-AAEF-12871F2463F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765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073DCDDE-33D2-46A7-B470-F9370DB94D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8066087-7CE7-4D78-B998-4160756869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7494DF6-794C-4A18-8DD5-C7509A93F2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0A-ECB5-4241-8711-E93198E77A6A}" type="datetimeFigureOut">
              <a:rPr lang="en-US" smtClean="0"/>
              <a:t>1/1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FD92744-8D43-492C-9BED-BC1EB89881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4096DA3-FE61-45C3-8A7E-569AA94025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D656-1A1A-484E-AAEF-12871F2463F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5355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D5A1F6A-7DF2-4B9A-AE88-40A1F9AEF2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28F36E8-2DC3-4923-8314-615F9121F0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7AD4072-9097-4E6C-9F1E-696F1BDF32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0A-ECB5-4241-8711-E93198E77A6A}" type="datetimeFigureOut">
              <a:rPr lang="en-US" smtClean="0"/>
              <a:t>1/1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728D811-F868-4E57-AF95-C89B36B0FD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AD5D3C6-633F-47CA-827F-62064A05A9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D656-1A1A-484E-AAEF-12871F2463F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515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FC6973B-1496-4A0E-99B0-97FFDD3A7A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1268A13-2F17-4056-891C-17A367F54F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E29A742-EE5A-4A83-9E2F-50CE6AD79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0A-ECB5-4241-8711-E93198E77A6A}" type="datetimeFigureOut">
              <a:rPr lang="en-US" smtClean="0"/>
              <a:t>1/1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24DEE80-EB52-4190-827A-A1D651D4B4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DCF171F-5B1A-4D48-8AF7-4503248C1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D656-1A1A-484E-AAEF-12871F2463F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7993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E18C635-D2C6-4726-A370-E954C8DBEB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BA25255-9097-45BB-A192-0CCBA8DF3B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81801F5E-DBF0-4837-94C1-C50D501CD1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60EFDA9-98F0-4CA0-80AE-D8EB0F3765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0A-ECB5-4241-8711-E93198E77A6A}" type="datetimeFigureOut">
              <a:rPr lang="en-US" smtClean="0"/>
              <a:t>1/16/20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68A7BF6-51A2-47E9-BEBF-2EC421892D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93FDF07-5560-4261-AA9A-D437807531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D656-1A1A-484E-AAEF-12871F2463F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518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684F857-631B-47AA-9DB0-10409D7C5C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DFDB886-290F-4E21-83BC-B789B1624D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E92E06B-0FCD-4FDF-A7BF-E383E8AA29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F11B20F9-184E-47BE-A4D7-494DC4F7AA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FEB9FE7F-46AC-4BDF-8656-4ED5AF651F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4E2FBE0-42D3-4529-8065-04577C8C1B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0A-ECB5-4241-8711-E93198E77A6A}" type="datetimeFigureOut">
              <a:rPr lang="en-US" smtClean="0"/>
              <a:t>1/16/2022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6BD9EB1D-75C0-483F-A763-18C3049C13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BBEDF101-FE40-4FA0-A967-187A504FC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D656-1A1A-484E-AAEF-12871F2463F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178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A244370-E52F-4520-8874-14A07649C2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7DBC1CB2-9A9F-4A88-9A1E-778D1A3EAF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0A-ECB5-4241-8711-E93198E77A6A}" type="datetimeFigureOut">
              <a:rPr lang="en-US" smtClean="0"/>
              <a:t>1/16/2022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6B16D8C1-D119-4DDB-82ED-515EC427C0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BBE217C-1373-4029-89F3-D792D246D5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D656-1A1A-484E-AAEF-12871F2463F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034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58CD761-9E1D-4A2D-A5B5-712A20518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0A-ECB5-4241-8711-E93198E77A6A}" type="datetimeFigureOut">
              <a:rPr lang="en-US" smtClean="0"/>
              <a:t>1/16/2022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1051C428-345D-4EBF-AE2D-04E5C5BBAE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B52D3B9-15C8-4272-AA24-DEE5704C41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D656-1A1A-484E-AAEF-12871F2463F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782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67F0007-C499-45AF-AD81-329DDE68C4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AA15207-2348-483C-9473-E79E85874EF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E2E8EDB-5A70-4F15-915C-E6884E06AE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2215583-C48C-42CF-BD41-C9E959A44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0A-ECB5-4241-8711-E93198E77A6A}" type="datetimeFigureOut">
              <a:rPr lang="en-US" smtClean="0"/>
              <a:t>1/16/20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2CEE280-7649-49AF-8DEF-6AF1F179D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08C9200-1CC4-4D94-8A4E-8C436ACC1B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D656-1A1A-484E-AAEF-12871F2463F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733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7A326D4-FF11-490C-B502-96124C93B0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398D06F-1D53-4544-818B-0D8CB53C01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ED49D09-B2C8-4B99-AC47-11C8F8DA85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FDBBD4F-388E-404B-850F-EABADBE31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0A-ECB5-4241-8711-E93198E77A6A}" type="datetimeFigureOut">
              <a:rPr lang="en-US" smtClean="0"/>
              <a:t>1/16/20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E5C98A4-F442-427B-9BDE-A7F6C03C1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E223F29-E0EB-48DA-ABCB-F47B7FEA8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D656-1A1A-484E-AAEF-12871F2463F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979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BDAF2367-2B08-4428-89BF-E34BDE035E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E3F0729-C398-4D52-87F7-3AB8ACC9AB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9FDE6DD-A04D-4926-8521-6AA033B763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82DD0A-ECB5-4241-8711-E93198E77A6A}" type="datetimeFigureOut">
              <a:rPr lang="en-US" smtClean="0"/>
              <a:t>1/1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99939D3-40DC-42C9-BA73-EB309D9332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BBF125D-9030-4D02-9F10-F721E0DCDA8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59D656-1A1A-484E-AAEF-12871F2463F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296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>
            <a:extLst>
              <a:ext uri="{FF2B5EF4-FFF2-40B4-BE49-F238E27FC236}">
                <a16:creationId xmlns:a16="http://schemas.microsoft.com/office/drawing/2014/main" id="{F2FA9F66-F1C5-4F00-9EB8-F2054CC78F9E}"/>
              </a:ext>
            </a:extLst>
          </p:cNvPr>
          <p:cNvSpPr/>
          <p:nvPr/>
        </p:nvSpPr>
        <p:spPr>
          <a:xfrm>
            <a:off x="1701849" y="1877444"/>
            <a:ext cx="8788302" cy="1754326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5400" dirty="0">
                <a:ln w="0"/>
                <a:gradFill>
                  <a:gsLst>
                    <a:gs pos="0">
                      <a:schemeClr val="accent5">
                        <a:lumMod val="50000"/>
                      </a:schemeClr>
                    </a:gs>
                    <a:gs pos="50000">
                      <a:schemeClr val="accent5"/>
                    </a:gs>
                    <a:gs pos="100000">
                      <a:schemeClr val="accent5">
                        <a:lumMod val="60000"/>
                        <a:lumOff val="40000"/>
                      </a:schemeClr>
                    </a:gs>
                  </a:gsLst>
                  <a:lin ang="5400000"/>
                </a:gradFill>
                <a:effectLst>
                  <a:reflection blurRad="6350" stA="53000" endA="300" endPos="35500" dir="5400000" sy="-90000" algn="bl" rotWithShape="0"/>
                </a:effectLst>
              </a:rPr>
              <a:t>Metabolites with lower abundance in CRC samples</a:t>
            </a:r>
            <a:endParaRPr lang="en-US" sz="5400" b="0" cap="none" spc="0" dirty="0">
              <a:ln w="0"/>
              <a:gradFill>
                <a:gsLst>
                  <a:gs pos="0">
                    <a:schemeClr val="accent5">
                      <a:lumMod val="50000"/>
                    </a:schemeClr>
                  </a:gs>
                  <a:gs pos="50000">
                    <a:schemeClr val="accent5"/>
                  </a:gs>
                  <a:gs pos="100000">
                    <a:schemeClr val="accent5">
                      <a:lumMod val="60000"/>
                      <a:lumOff val="40000"/>
                    </a:schemeClr>
                  </a:gs>
                </a:gsLst>
                <a:lin ang="5400000"/>
              </a:gradFill>
              <a:effectLst>
                <a:reflection blurRad="6350" stA="53000" endA="300" endPos="35500" dir="5400000" sy="-90000" algn="bl" rotWithShape="0"/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23621191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>
            <a:extLst>
              <a:ext uri="{FF2B5EF4-FFF2-40B4-BE49-F238E27FC236}">
                <a16:creationId xmlns:a16="http://schemas.microsoft.com/office/drawing/2014/main" id="{DBA46FBB-D3AB-485F-951A-E6C3BF9013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733" y="591056"/>
            <a:ext cx="3400481" cy="2210312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E3B4FF89-C45F-4E24-B963-61E855708F2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023671" y="0"/>
            <a:ext cx="73152" cy="6858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Immagine 8">
            <a:extLst>
              <a:ext uri="{FF2B5EF4-FFF2-40B4-BE49-F238E27FC236}">
                <a16:creationId xmlns:a16="http://schemas.microsoft.com/office/drawing/2014/main" id="{F6816028-BDDE-42C0-911A-5EA1A7F9019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5216" y="590703"/>
            <a:ext cx="3401568" cy="2211019"/>
          </a:xfrm>
          <a:prstGeom prst="rect">
            <a:avLst/>
          </a:prstGeom>
        </p:spPr>
      </p:pic>
      <p:sp>
        <p:nvSpPr>
          <p:cNvPr id="22" name="Rectangle 21">
            <a:extLst>
              <a:ext uri="{FF2B5EF4-FFF2-40B4-BE49-F238E27FC236}">
                <a16:creationId xmlns:a16="http://schemas.microsoft.com/office/drawing/2014/main" id="{14F25C03-EF67-4344-8AEA-7B3FA0DED02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107836" y="0"/>
            <a:ext cx="73152" cy="6858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5" name="Immagine 14">
            <a:extLst>
              <a:ext uri="{FF2B5EF4-FFF2-40B4-BE49-F238E27FC236}">
                <a16:creationId xmlns:a16="http://schemas.microsoft.com/office/drawing/2014/main" id="{231ED8A2-A69B-4637-8E8D-1376D86B5FC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2040" y="592395"/>
            <a:ext cx="3401568" cy="2211019"/>
          </a:xfrm>
          <a:prstGeom prst="rect">
            <a:avLst/>
          </a:prstGeom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F74793DE-3651-410B-B243-8F0B1468E6A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6059424" y="-2665476"/>
            <a:ext cx="73152" cy="12188952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Immagine 10">
            <a:extLst>
              <a:ext uri="{FF2B5EF4-FFF2-40B4-BE49-F238E27FC236}">
                <a16:creationId xmlns:a16="http://schemas.microsoft.com/office/drawing/2014/main" id="{1B1CAEE2-F73F-4ABB-B46C-1E8B05C000E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066" y="4054585"/>
            <a:ext cx="3401568" cy="2211019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5BF2C140-FF31-489D-907A-8904C45A362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8095" y="4054585"/>
            <a:ext cx="3401568" cy="2211019"/>
          </a:xfrm>
          <a:prstGeom prst="rect">
            <a:avLst/>
          </a:prstGeom>
        </p:spPr>
      </p:pic>
      <p:pic>
        <p:nvPicPr>
          <p:cNvPr id="13" name="Immagine 12">
            <a:extLst>
              <a:ext uri="{FF2B5EF4-FFF2-40B4-BE49-F238E27FC236}">
                <a16:creationId xmlns:a16="http://schemas.microsoft.com/office/drawing/2014/main" id="{21873ABF-498D-46F5-BEE7-38A7E6F793B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2124" y="4054585"/>
            <a:ext cx="3401568" cy="22110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32458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6EFC10D2-8476-4CC3-8340-A9DC2423CBB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733" y="591056"/>
            <a:ext cx="3400481" cy="2210312"/>
          </a:xfrm>
          <a:prstGeom prst="rect">
            <a:avLst/>
          </a:prstGeom>
        </p:spPr>
      </p:pic>
      <p:sp>
        <p:nvSpPr>
          <p:cNvPr id="18" name="Rectangle 17">
            <a:extLst>
              <a:ext uri="{FF2B5EF4-FFF2-40B4-BE49-F238E27FC236}">
                <a16:creationId xmlns:a16="http://schemas.microsoft.com/office/drawing/2014/main" id="{E3B4FF89-C45F-4E24-B963-61E855708F2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023671" y="0"/>
            <a:ext cx="73152" cy="6858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" name="Immagine 12">
            <a:extLst>
              <a:ext uri="{FF2B5EF4-FFF2-40B4-BE49-F238E27FC236}">
                <a16:creationId xmlns:a16="http://schemas.microsoft.com/office/drawing/2014/main" id="{59C9ABB6-26A6-418F-9DA7-6125EF3DE40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5216" y="590703"/>
            <a:ext cx="3401568" cy="2211019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14F25C03-EF67-4344-8AEA-7B3FA0DED02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107836" y="0"/>
            <a:ext cx="73152" cy="6858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8213E04D-29BF-4D4D-AD72-37245BDEB02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2040" y="592395"/>
            <a:ext cx="3401568" cy="2211019"/>
          </a:xfrm>
          <a:prstGeom prst="rect">
            <a:avLst/>
          </a:prstGeom>
        </p:spPr>
      </p:pic>
      <p:sp>
        <p:nvSpPr>
          <p:cNvPr id="22" name="Rectangle 21">
            <a:extLst>
              <a:ext uri="{FF2B5EF4-FFF2-40B4-BE49-F238E27FC236}">
                <a16:creationId xmlns:a16="http://schemas.microsoft.com/office/drawing/2014/main" id="{F74793DE-3651-410B-B243-8F0B1468E6A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6059424" y="-2665476"/>
            <a:ext cx="73152" cy="12188952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74C70EAB-294C-435A-8582-23E564B8D0D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066" y="4054585"/>
            <a:ext cx="3401568" cy="2211019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4843BC03-35AD-44EA-8689-19C8BE999E1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8095" y="4054585"/>
            <a:ext cx="3401568" cy="2211019"/>
          </a:xfrm>
          <a:prstGeom prst="rect">
            <a:avLst/>
          </a:prstGeom>
        </p:spPr>
      </p:pic>
      <p:pic>
        <p:nvPicPr>
          <p:cNvPr id="11" name="Immagine 10">
            <a:extLst>
              <a:ext uri="{FF2B5EF4-FFF2-40B4-BE49-F238E27FC236}">
                <a16:creationId xmlns:a16="http://schemas.microsoft.com/office/drawing/2014/main" id="{BDD351AF-1CF1-46CF-977F-6D76CCB9D98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2124" y="4054585"/>
            <a:ext cx="3401568" cy="22110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43951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magine 10">
            <a:extLst>
              <a:ext uri="{FF2B5EF4-FFF2-40B4-BE49-F238E27FC236}">
                <a16:creationId xmlns:a16="http://schemas.microsoft.com/office/drawing/2014/main" id="{DA4080C8-E181-4B56-8580-511EEBCEBE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733" y="591056"/>
            <a:ext cx="3400481" cy="2210312"/>
          </a:xfrm>
          <a:prstGeom prst="rect">
            <a:avLst/>
          </a:prstGeom>
        </p:spPr>
      </p:pic>
      <p:sp>
        <p:nvSpPr>
          <p:cNvPr id="18" name="Rectangle 17">
            <a:extLst>
              <a:ext uri="{FF2B5EF4-FFF2-40B4-BE49-F238E27FC236}">
                <a16:creationId xmlns:a16="http://schemas.microsoft.com/office/drawing/2014/main" id="{E3B4FF89-C45F-4E24-B963-61E855708F2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023671" y="0"/>
            <a:ext cx="73152" cy="6858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FA90B2D4-7307-4746-9C4E-C47568822DA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5216" y="590703"/>
            <a:ext cx="3401568" cy="2211019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14F25C03-EF67-4344-8AEA-7B3FA0DED02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107836" y="0"/>
            <a:ext cx="73152" cy="6858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E24C45FB-9019-467C-94ED-F8BA9D9204D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2040" y="592395"/>
            <a:ext cx="3401568" cy="2211019"/>
          </a:xfrm>
          <a:prstGeom prst="rect">
            <a:avLst/>
          </a:prstGeom>
        </p:spPr>
      </p:pic>
      <p:sp>
        <p:nvSpPr>
          <p:cNvPr id="22" name="Rectangle 21">
            <a:extLst>
              <a:ext uri="{FF2B5EF4-FFF2-40B4-BE49-F238E27FC236}">
                <a16:creationId xmlns:a16="http://schemas.microsoft.com/office/drawing/2014/main" id="{F74793DE-3651-410B-B243-8F0B1468E6A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6059424" y="-2665476"/>
            <a:ext cx="73152" cy="12188952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" name="Immagine 12">
            <a:extLst>
              <a:ext uri="{FF2B5EF4-FFF2-40B4-BE49-F238E27FC236}">
                <a16:creationId xmlns:a16="http://schemas.microsoft.com/office/drawing/2014/main" id="{B822C59B-AD7A-4418-AD7C-1F3588A9E7A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066" y="4054585"/>
            <a:ext cx="3401568" cy="2211019"/>
          </a:xfrm>
          <a:prstGeom prst="rect">
            <a:avLst/>
          </a:prstGeom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0CC6A532-43B0-44C5-B286-384070A5DAC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8095" y="4054585"/>
            <a:ext cx="3401568" cy="2211019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8B441D1C-F35E-4C97-AB5C-89FF55D31B4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2124" y="4054585"/>
            <a:ext cx="3401568" cy="22110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39304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956AC152-4628-4BE7-B485-05A86665E0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632" y="2282863"/>
            <a:ext cx="3517119" cy="2286127"/>
          </a:xfrm>
          <a:prstGeom prst="rect">
            <a:avLst/>
          </a:prstGeom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Immagine 6">
            <a:extLst>
              <a:ext uri="{FF2B5EF4-FFF2-40B4-BE49-F238E27FC236}">
                <a16:creationId xmlns:a16="http://schemas.microsoft.com/office/drawing/2014/main" id="{40F47A4D-22BE-456C-9FC3-3617411EC82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0676" y="2276290"/>
            <a:ext cx="3537345" cy="2299274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Immagine 2">
            <a:extLst>
              <a:ext uri="{FF2B5EF4-FFF2-40B4-BE49-F238E27FC236}">
                <a16:creationId xmlns:a16="http://schemas.microsoft.com/office/drawing/2014/main" id="{5289F52C-6653-4C67-9A14-A0D03C6EB9B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2336" y="2282864"/>
            <a:ext cx="3517120" cy="22861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50045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>
            <a:extLst>
              <a:ext uri="{FF2B5EF4-FFF2-40B4-BE49-F238E27FC236}">
                <a16:creationId xmlns:a16="http://schemas.microsoft.com/office/drawing/2014/main" id="{F2FA9F66-F1C5-4F00-9EB8-F2054CC78F9E}"/>
              </a:ext>
            </a:extLst>
          </p:cNvPr>
          <p:cNvSpPr/>
          <p:nvPr/>
        </p:nvSpPr>
        <p:spPr>
          <a:xfrm>
            <a:off x="1701849" y="1877444"/>
            <a:ext cx="8788302" cy="1754326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5400" dirty="0">
                <a:ln w="0"/>
                <a:gradFill>
                  <a:gsLst>
                    <a:gs pos="0">
                      <a:schemeClr val="accent5">
                        <a:lumMod val="50000"/>
                      </a:schemeClr>
                    </a:gs>
                    <a:gs pos="50000">
                      <a:schemeClr val="accent5"/>
                    </a:gs>
                    <a:gs pos="100000">
                      <a:schemeClr val="accent5">
                        <a:lumMod val="60000"/>
                        <a:lumOff val="40000"/>
                      </a:schemeClr>
                    </a:gs>
                  </a:gsLst>
                  <a:lin ang="5400000"/>
                </a:gradFill>
                <a:effectLst>
                  <a:reflection blurRad="6350" stA="53000" endA="300" endPos="35500" dir="5400000" sy="-90000" algn="bl" rotWithShape="0"/>
                </a:effectLst>
              </a:rPr>
              <a:t>Metabolites with higher abundance in CRC samples</a:t>
            </a:r>
            <a:endParaRPr lang="en-US" sz="5400" b="0" cap="none" spc="0" dirty="0">
              <a:ln w="0"/>
              <a:gradFill>
                <a:gsLst>
                  <a:gs pos="0">
                    <a:schemeClr val="accent5">
                      <a:lumMod val="50000"/>
                    </a:schemeClr>
                  </a:gs>
                  <a:gs pos="50000">
                    <a:schemeClr val="accent5"/>
                  </a:gs>
                  <a:gs pos="100000">
                    <a:schemeClr val="accent5">
                      <a:lumMod val="60000"/>
                      <a:lumOff val="40000"/>
                    </a:schemeClr>
                  </a:gs>
                </a:gsLst>
                <a:lin ang="5400000"/>
              </a:gradFill>
              <a:effectLst>
                <a:reflection blurRad="6350" stA="53000" endA="300" endPos="35500" dir="5400000" sy="-90000" algn="bl" rotWithShape="0"/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9224594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Immagine 14">
            <a:extLst>
              <a:ext uri="{FF2B5EF4-FFF2-40B4-BE49-F238E27FC236}">
                <a16:creationId xmlns:a16="http://schemas.microsoft.com/office/drawing/2014/main" id="{C7E96C18-5DC8-424E-8973-D62E703564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733" y="591056"/>
            <a:ext cx="3400481" cy="2210312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E3B4FF89-C45F-4E24-B963-61E855708F2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023671" y="0"/>
            <a:ext cx="73152" cy="6858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091DDD5A-55FF-491A-84CD-6329A0861E4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5216" y="590703"/>
            <a:ext cx="3401568" cy="2211019"/>
          </a:xfrm>
          <a:prstGeom prst="rect">
            <a:avLst/>
          </a:prstGeom>
        </p:spPr>
      </p:pic>
      <p:sp>
        <p:nvSpPr>
          <p:cNvPr id="22" name="Rectangle 21">
            <a:extLst>
              <a:ext uri="{FF2B5EF4-FFF2-40B4-BE49-F238E27FC236}">
                <a16:creationId xmlns:a16="http://schemas.microsoft.com/office/drawing/2014/main" id="{14F25C03-EF67-4344-8AEA-7B3FA0DED02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107836" y="0"/>
            <a:ext cx="73152" cy="6858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" name="Immagine 12">
            <a:extLst>
              <a:ext uri="{FF2B5EF4-FFF2-40B4-BE49-F238E27FC236}">
                <a16:creationId xmlns:a16="http://schemas.microsoft.com/office/drawing/2014/main" id="{55376955-F338-49A7-822B-EB1521412C1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2040" y="592395"/>
            <a:ext cx="3401568" cy="2211019"/>
          </a:xfrm>
          <a:prstGeom prst="rect">
            <a:avLst/>
          </a:prstGeom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F74793DE-3651-410B-B243-8F0B1468E6A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6059424" y="-2665476"/>
            <a:ext cx="73152" cy="12188952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Immagine 10">
            <a:extLst>
              <a:ext uri="{FF2B5EF4-FFF2-40B4-BE49-F238E27FC236}">
                <a16:creationId xmlns:a16="http://schemas.microsoft.com/office/drawing/2014/main" id="{B6AC6D81-A7E4-4271-B0F1-40484354AA5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066" y="4054585"/>
            <a:ext cx="3401568" cy="2211019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A15FDB7F-3A3D-471E-B1D4-9CF1E9A4232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8095" y="4054585"/>
            <a:ext cx="3401568" cy="2211019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07137880-9812-4B62-8220-835E96F08D1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2124" y="4054585"/>
            <a:ext cx="3401568" cy="22110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86828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178A6521-83E0-490E-A315-D74EF59214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733" y="591056"/>
            <a:ext cx="3400481" cy="2210312"/>
          </a:xfrm>
          <a:prstGeom prst="rect">
            <a:avLst/>
          </a:prstGeom>
        </p:spPr>
      </p:pic>
      <p:sp>
        <p:nvSpPr>
          <p:cNvPr id="18" name="Rectangle 17">
            <a:extLst>
              <a:ext uri="{FF2B5EF4-FFF2-40B4-BE49-F238E27FC236}">
                <a16:creationId xmlns:a16="http://schemas.microsoft.com/office/drawing/2014/main" id="{E3B4FF89-C45F-4E24-B963-61E855708F2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023671" y="0"/>
            <a:ext cx="73152" cy="6858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Immagine 8">
            <a:extLst>
              <a:ext uri="{FF2B5EF4-FFF2-40B4-BE49-F238E27FC236}">
                <a16:creationId xmlns:a16="http://schemas.microsoft.com/office/drawing/2014/main" id="{6C3CA9C4-2777-4933-A790-72EEDFC4EBD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5216" y="590703"/>
            <a:ext cx="3401568" cy="2211019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14F25C03-EF67-4344-8AEA-7B3FA0DED02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107836" y="0"/>
            <a:ext cx="73152" cy="6858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EC96B90B-8482-4F17-BF59-9225D413888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2040" y="592395"/>
            <a:ext cx="3401568" cy="2211019"/>
          </a:xfrm>
          <a:prstGeom prst="rect">
            <a:avLst/>
          </a:prstGeom>
        </p:spPr>
      </p:pic>
      <p:sp>
        <p:nvSpPr>
          <p:cNvPr id="22" name="Rectangle 21">
            <a:extLst>
              <a:ext uri="{FF2B5EF4-FFF2-40B4-BE49-F238E27FC236}">
                <a16:creationId xmlns:a16="http://schemas.microsoft.com/office/drawing/2014/main" id="{F74793DE-3651-410B-B243-8F0B1468E6A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6059424" y="-2665476"/>
            <a:ext cx="73152" cy="12188952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" name="Immagine 12">
            <a:extLst>
              <a:ext uri="{FF2B5EF4-FFF2-40B4-BE49-F238E27FC236}">
                <a16:creationId xmlns:a16="http://schemas.microsoft.com/office/drawing/2014/main" id="{B645A3CF-BA9F-413B-AB6B-B0691A86ECD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066" y="4054585"/>
            <a:ext cx="3401568" cy="2211019"/>
          </a:xfrm>
          <a:prstGeom prst="rect">
            <a:avLst/>
          </a:prstGeom>
        </p:spPr>
      </p:pic>
      <p:pic>
        <p:nvPicPr>
          <p:cNvPr id="11" name="Immagine 10">
            <a:extLst>
              <a:ext uri="{FF2B5EF4-FFF2-40B4-BE49-F238E27FC236}">
                <a16:creationId xmlns:a16="http://schemas.microsoft.com/office/drawing/2014/main" id="{A749617F-BB8A-4350-93B5-E68D9F2F0CA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8095" y="4054585"/>
            <a:ext cx="3401568" cy="2211019"/>
          </a:xfrm>
          <a:prstGeom prst="rect">
            <a:avLst/>
          </a:prstGeom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9F97D849-06C4-44AF-AEA8-EB25B4D2827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2124" y="4054585"/>
            <a:ext cx="3401568" cy="22110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109282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2CB8E108-C9BA-4B02-B293-DA9892980F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5838" y="321734"/>
            <a:ext cx="4469491" cy="2905170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417CDA24-35F8-4540-8C52-3096D6D9494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050280" y="0"/>
            <a:ext cx="91440" cy="6858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5480EE97-981D-4AA4-92B8-DE4FE47BA12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29586" y="321734"/>
            <a:ext cx="4469491" cy="2905170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8658BFE0-4E65-4174-9C75-687C94E8827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3383280"/>
            <a:ext cx="6126480" cy="9144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FA75DFED-A0C1-4A83-BE1D-0271C1826EF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065520" y="3383280"/>
            <a:ext cx="6126480" cy="9144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F356088B-76BA-4F98-9DDD-E17B6B6281B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7075" y="3631096"/>
            <a:ext cx="4247015" cy="2760560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B998E921-127E-4BCD-95F9-3C659AEC185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40824" y="3631096"/>
            <a:ext cx="4247015" cy="2760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38814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14</Words>
  <Application>Microsoft Office PowerPoint</Application>
  <PresentationFormat>Widescreen</PresentationFormat>
  <Paragraphs>2</Paragraphs>
  <Slides>9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Jacopo TROISI</dc:creator>
  <cp:lastModifiedBy>Jacopo TROISI</cp:lastModifiedBy>
  <cp:revision>2</cp:revision>
  <dcterms:created xsi:type="dcterms:W3CDTF">2022-01-09T18:17:54Z</dcterms:created>
  <dcterms:modified xsi:type="dcterms:W3CDTF">2022-01-16T15:31:56Z</dcterms:modified>
</cp:coreProperties>
</file>